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09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hner, Laya" initials="LL" lastIdx="2" clrIdx="0">
    <p:extLst>
      <p:ext uri="{19B8F6BF-5375-455C-9EA6-DF929625EA0E}">
        <p15:presenceInfo xmlns:p15="http://schemas.microsoft.com/office/powerpoint/2012/main" userId="S-1-5-21-362817340-543905452-3763403103-11163" providerId="AD"/>
      </p:ext>
    </p:extLst>
  </p:cmAuthor>
  <p:cmAuthor id="2" name="Eschenbeck, Heike" initials="EH" lastIdx="4" clrIdx="1">
    <p:extLst>
      <p:ext uri="{19B8F6BF-5375-455C-9EA6-DF929625EA0E}">
        <p15:presenceInfo xmlns:p15="http://schemas.microsoft.com/office/powerpoint/2012/main" userId="S-1-5-21-362817340-543905452-3763403103-495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139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932" y="114"/>
      </p:cViewPr>
      <p:guideLst>
        <p:guide orient="horz" pos="2160"/>
        <p:guide pos="30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890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0687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90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1885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743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7317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106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871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9153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85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6470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0893DE-B6D6-4D3A-9026-8FECC579E04F}" type="datetimeFigureOut">
              <a:rPr lang="de-DE" smtClean="0"/>
              <a:t>19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6511C-9DE4-4244-8D6E-59E30B0C723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3088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7EDF680F-9696-4112-963A-0ED5CC4A9CF1}"/>
              </a:ext>
            </a:extLst>
          </p:cNvPr>
          <p:cNvSpPr txBox="1"/>
          <p:nvPr/>
        </p:nvSpPr>
        <p:spPr>
          <a:xfrm>
            <a:off x="1122947" y="2878266"/>
            <a:ext cx="3520291" cy="17878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>
              <a:lnSpc>
                <a:spcPct val="150000"/>
              </a:lnSpc>
            </a:pP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ntal Health Problems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di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difficulties score (SDQ &lt; 20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fear of weight gain (WCS &lt; 58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problematic substance use (CRAFFT-d &lt; 2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hazardous alcohol consumption (AUDIT &lt; 20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depressive symptoms (PHQ-A &lt; 10)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AC6D1865-55C4-41F6-8F67-8F8720375622}"/>
              </a:ext>
            </a:extLst>
          </p:cNvPr>
          <p:cNvSpPr txBox="1"/>
          <p:nvPr/>
        </p:nvSpPr>
        <p:spPr>
          <a:xfrm>
            <a:off x="5262764" y="2878267"/>
            <a:ext cx="3866488" cy="2829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Risk or With Mental Health Problem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dition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difficulties score (SDQ ≥ 20)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ar of weight gain (WCS ≥ 58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 &lt; 5th age/sex percentile AND fear of weight gain (SEED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lematic substance use (CRAFFT-d ≥ 2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zardous alcohol consumption (AUDIT ≥ 20) 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ressive symptoms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(PHQ-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10)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icidality (PHQ-A item on suicidality answered positively)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1FCD138-72F9-4F3A-98BF-09733ED1B4F1}"/>
              </a:ext>
            </a:extLst>
          </p:cNvPr>
          <p:cNvSpPr txBox="1"/>
          <p:nvPr/>
        </p:nvSpPr>
        <p:spPr>
          <a:xfrm>
            <a:off x="4313359" y="1451836"/>
            <a:ext cx="1303670" cy="6131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igibl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ent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7" indent="-285757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&gt; 11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A60A61C1-BF0E-4FDD-A03F-97E66D6CE798}"/>
              </a:ext>
            </a:extLst>
          </p:cNvPr>
          <p:cNvSpPr txBox="1"/>
          <p:nvPr/>
        </p:nvSpPr>
        <p:spPr>
          <a:xfrm>
            <a:off x="1022555" y="609600"/>
            <a:ext cx="8180484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S4</a:t>
            </a: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54EC9C75-5D64-4870-B872-F111F233A7F7}"/>
              </a:ext>
            </a:extLst>
          </p:cNvPr>
          <p:cNvSpPr/>
          <p:nvPr/>
        </p:nvSpPr>
        <p:spPr>
          <a:xfrm>
            <a:off x="776748" y="1150625"/>
            <a:ext cx="8654635" cy="48259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7" name="Rechteck 86">
            <a:extLst>
              <a:ext uri="{FF2B5EF4-FFF2-40B4-BE49-F238E27FC236}">
                <a16:creationId xmlns:a16="http://schemas.microsoft.com/office/drawing/2014/main" id="{FE83ADDB-F2B5-402A-8D4C-1A20386AFC56}"/>
              </a:ext>
            </a:extLst>
          </p:cNvPr>
          <p:cNvSpPr/>
          <p:nvPr/>
        </p:nvSpPr>
        <p:spPr>
          <a:xfrm>
            <a:off x="686480" y="5976621"/>
            <a:ext cx="3679212" cy="3361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 Assignment for the Primary Outcome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Verbinder: gewinkelt 14">
            <a:extLst>
              <a:ext uri="{FF2B5EF4-FFF2-40B4-BE49-F238E27FC236}">
                <a16:creationId xmlns:a16="http://schemas.microsoft.com/office/drawing/2014/main" id="{BC070769-1B25-4D08-B83D-C01B3ADD9698}"/>
              </a:ext>
            </a:extLst>
          </p:cNvPr>
          <p:cNvCxnSpPr>
            <a:cxnSpLocks/>
            <a:stCxn id="5" idx="2"/>
            <a:endCxn id="2" idx="0"/>
          </p:cNvCxnSpPr>
          <p:nvPr/>
        </p:nvCxnSpPr>
        <p:spPr>
          <a:xfrm rot="5400000">
            <a:off x="3517488" y="1430559"/>
            <a:ext cx="813313" cy="208210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Verbinder: gewinkelt 37">
            <a:extLst>
              <a:ext uri="{FF2B5EF4-FFF2-40B4-BE49-F238E27FC236}">
                <a16:creationId xmlns:a16="http://schemas.microsoft.com/office/drawing/2014/main" id="{4FBF525A-2F0B-499C-ACB2-4272D44E96C9}"/>
              </a:ext>
            </a:extLst>
          </p:cNvPr>
          <p:cNvCxnSpPr>
            <a:cxnSpLocks/>
            <a:stCxn id="5" idx="2"/>
            <a:endCxn id="4" idx="0"/>
          </p:cNvCxnSpPr>
          <p:nvPr/>
        </p:nvCxnSpPr>
        <p:spPr>
          <a:xfrm rot="16200000" flipH="1">
            <a:off x="5673944" y="1356203"/>
            <a:ext cx="813314" cy="223081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1860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1</Words>
  <Application>Microsoft Office PowerPoint</Application>
  <PresentationFormat>A4 Paper (210x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hner, Laya</dc:creator>
  <cp:lastModifiedBy>Monique</cp:lastModifiedBy>
  <cp:revision>27</cp:revision>
  <dcterms:created xsi:type="dcterms:W3CDTF">2025-06-05T07:36:11Z</dcterms:created>
  <dcterms:modified xsi:type="dcterms:W3CDTF">2026-02-19T00:13:34Z</dcterms:modified>
</cp:coreProperties>
</file>